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460" userDrawn="1">
          <p15:clr>
            <a:srgbClr val="A4A3A4"/>
          </p15:clr>
        </p15:guide>
        <p15:guide id="2" pos="2479" userDrawn="1">
          <p15:clr>
            <a:srgbClr val="A4A3A4"/>
          </p15:clr>
        </p15:guide>
        <p15:guide id="3" orient="horz" pos="788" userDrawn="1">
          <p15:clr>
            <a:srgbClr val="A4A3A4"/>
          </p15:clr>
        </p15:guide>
        <p15:guide id="4" pos="370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EF6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80" d="100"/>
          <a:sy n="80" d="100"/>
        </p:scale>
        <p:origin x="1656" y="60"/>
      </p:cViewPr>
      <p:guideLst>
        <p:guide orient="horz" pos="5460"/>
        <p:guide pos="2479"/>
        <p:guide orient="horz" pos="788"/>
        <p:guide pos="37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5891-4177-48C7-8ECE-2291C6C5FD6D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98AF7-F35E-4F27-B154-F6E4FB50E15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81708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5891-4177-48C7-8ECE-2291C6C5FD6D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98AF7-F35E-4F27-B154-F6E4FB50E15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6004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5891-4177-48C7-8ECE-2291C6C5FD6D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98AF7-F35E-4F27-B154-F6E4FB50E15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309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5891-4177-48C7-8ECE-2291C6C5FD6D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98AF7-F35E-4F27-B154-F6E4FB50E15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563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5891-4177-48C7-8ECE-2291C6C5FD6D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98AF7-F35E-4F27-B154-F6E4FB50E15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770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5891-4177-48C7-8ECE-2291C6C5FD6D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98AF7-F35E-4F27-B154-F6E4FB50E15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88214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5891-4177-48C7-8ECE-2291C6C5FD6D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98AF7-F35E-4F27-B154-F6E4FB50E15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129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5891-4177-48C7-8ECE-2291C6C5FD6D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98AF7-F35E-4F27-B154-F6E4FB50E15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10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5891-4177-48C7-8ECE-2291C6C5FD6D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98AF7-F35E-4F27-B154-F6E4FB50E15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38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5891-4177-48C7-8ECE-2291C6C5FD6D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98AF7-F35E-4F27-B154-F6E4FB50E15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582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D95891-4177-48C7-8ECE-2291C6C5FD6D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898AF7-F35E-4F27-B154-F6E4FB50E15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6654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D95891-4177-48C7-8ECE-2291C6C5FD6D}" type="datetimeFigureOut">
              <a:rPr lang="en-US" smtClean="0"/>
              <a:t>10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898AF7-F35E-4F27-B154-F6E4FB50E15C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2783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9">
            <a:extLst>
              <a:ext uri="{FF2B5EF4-FFF2-40B4-BE49-F238E27FC236}">
                <a16:creationId xmlns:a16="http://schemas.microsoft.com/office/drawing/2014/main" id="{2BDA511D-1DBE-44A5-8A88-747F0B7E05FC}"/>
              </a:ext>
            </a:extLst>
          </p:cNvPr>
          <p:cNvGrpSpPr/>
          <p:nvPr/>
        </p:nvGrpSpPr>
        <p:grpSpPr>
          <a:xfrm>
            <a:off x="6177278" y="1029643"/>
            <a:ext cx="4687237" cy="3958168"/>
            <a:chOff x="6337005" y="674687"/>
            <a:chExt cx="4677320" cy="3988003"/>
          </a:xfrm>
        </p:grpSpPr>
        <p:pic>
          <p:nvPicPr>
            <p:cNvPr id="16" name="Picture 20">
              <a:extLst>
                <a:ext uri="{FF2B5EF4-FFF2-40B4-BE49-F238E27FC236}">
                  <a16:creationId xmlns:a16="http://schemas.microsoft.com/office/drawing/2014/main" id="{29EFE36B-D699-4136-9638-08621F729C7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337005" y="674687"/>
              <a:ext cx="4677320" cy="39880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7" name="Picture 20">
              <a:extLst>
                <a:ext uri="{FF2B5EF4-FFF2-40B4-BE49-F238E27FC236}">
                  <a16:creationId xmlns:a16="http://schemas.microsoft.com/office/drawing/2014/main" id="{4CFC78C8-FF75-4C79-81D3-5AC82477B7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299" t="91700" r="26465" b="3857"/>
            <a:stretch/>
          </p:blipFill>
          <p:spPr bwMode="auto">
            <a:xfrm>
              <a:off x="9574684" y="934870"/>
              <a:ext cx="198120" cy="1771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12" name="Group 16">
            <a:extLst>
              <a:ext uri="{FF2B5EF4-FFF2-40B4-BE49-F238E27FC236}">
                <a16:creationId xmlns:a16="http://schemas.microsoft.com/office/drawing/2014/main" id="{2BF9922B-9AF5-4172-B840-F9E497EBE4B0}"/>
              </a:ext>
            </a:extLst>
          </p:cNvPr>
          <p:cNvGrpSpPr/>
          <p:nvPr/>
        </p:nvGrpSpPr>
        <p:grpSpPr>
          <a:xfrm>
            <a:off x="722256" y="1029642"/>
            <a:ext cx="5124519" cy="3958168"/>
            <a:chOff x="971481" y="674688"/>
            <a:chExt cx="5124519" cy="3997324"/>
          </a:xfrm>
        </p:grpSpPr>
        <p:pic>
          <p:nvPicPr>
            <p:cNvPr id="13" name="Picture 14">
              <a:extLst>
                <a:ext uri="{FF2B5EF4-FFF2-40B4-BE49-F238E27FC236}">
                  <a16:creationId xmlns:a16="http://schemas.microsoft.com/office/drawing/2014/main" id="{8A4858A5-3E06-496A-8E91-DA77C879539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1481" y="674688"/>
              <a:ext cx="5124519" cy="39973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" name="Picture 14">
              <a:extLst>
                <a:ext uri="{FF2B5EF4-FFF2-40B4-BE49-F238E27FC236}">
                  <a16:creationId xmlns:a16="http://schemas.microsoft.com/office/drawing/2014/main" id="{43497AB3-A6A4-4D3C-B7D8-1D75F465832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2753" t="14507" r="13390" b="80918"/>
            <a:stretch/>
          </p:blipFill>
          <p:spPr bwMode="auto">
            <a:xfrm>
              <a:off x="4648285" y="932488"/>
              <a:ext cx="197645" cy="1828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6" name="Textfeld 5">
            <a:extLst>
              <a:ext uri="{FF2B5EF4-FFF2-40B4-BE49-F238E27FC236}">
                <a16:creationId xmlns:a16="http://schemas.microsoft.com/office/drawing/2014/main" id="{0E816783-B9CC-4C0F-A5C5-26623405A0EF}"/>
              </a:ext>
            </a:extLst>
          </p:cNvPr>
          <p:cNvSpPr txBox="1"/>
          <p:nvPr/>
        </p:nvSpPr>
        <p:spPr>
          <a:xfrm>
            <a:off x="3034180" y="984730"/>
            <a:ext cx="101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roots</a:t>
            </a:r>
            <a:endParaRPr lang="en-US" dirty="0"/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BD2FC8A7-5187-4617-AC43-84E7AABA6140}"/>
              </a:ext>
            </a:extLst>
          </p:cNvPr>
          <p:cNvSpPr txBox="1"/>
          <p:nvPr/>
        </p:nvSpPr>
        <p:spPr>
          <a:xfrm>
            <a:off x="8465367" y="984730"/>
            <a:ext cx="101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err="1"/>
              <a:t>shoots</a:t>
            </a:r>
            <a:endParaRPr lang="en-US" dirty="0"/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476266BB-4D20-4058-A42C-7D056290CFCC}"/>
              </a:ext>
            </a:extLst>
          </p:cNvPr>
          <p:cNvSpPr txBox="1"/>
          <p:nvPr/>
        </p:nvSpPr>
        <p:spPr>
          <a:xfrm>
            <a:off x="963260" y="5374645"/>
            <a:ext cx="1042803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Palatino Linotype" panose="02040502050505030304" pitchFamily="18" charset="0"/>
              </a:rPr>
              <a:t>Figure S2</a:t>
            </a:r>
            <a:r>
              <a:rPr lang="en-US" sz="1400" dirty="0">
                <a:latin typeface="Palatino Linotype" panose="02040502050505030304" pitchFamily="18" charset="0"/>
              </a:rPr>
              <a:t>. Principal component analysis of metabolite distribution in roots (A) and shoots (B) of PEG- and salt-treated plants as compared to control.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96A33D43-538E-4313-9ACB-D61EB3E27DE6}"/>
              </a:ext>
            </a:extLst>
          </p:cNvPr>
          <p:cNvSpPr txBox="1"/>
          <p:nvPr/>
        </p:nvSpPr>
        <p:spPr>
          <a:xfrm>
            <a:off x="798473" y="984730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75905C55-2FF9-4A0C-99A0-426788641B2A}"/>
              </a:ext>
            </a:extLst>
          </p:cNvPr>
          <p:cNvSpPr txBox="1"/>
          <p:nvPr/>
        </p:nvSpPr>
        <p:spPr>
          <a:xfrm>
            <a:off x="6177671" y="984730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3094880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3</Words>
  <Application>Microsoft Office PowerPoint</Application>
  <PresentationFormat>Benutzerdefiniert</PresentationFormat>
  <Paragraphs>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Volodymyr Radchuk</dc:creator>
  <cp:lastModifiedBy>Volodymyr Radchuk</cp:lastModifiedBy>
  <cp:revision>23</cp:revision>
  <cp:lastPrinted>2020-04-02T08:32:07Z</cp:lastPrinted>
  <dcterms:created xsi:type="dcterms:W3CDTF">2019-11-28T15:16:17Z</dcterms:created>
  <dcterms:modified xsi:type="dcterms:W3CDTF">2020-10-30T10:06:06Z</dcterms:modified>
</cp:coreProperties>
</file>